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sldIdLst>
    <p:sldId id="256" r:id="rId2"/>
  </p:sldIdLst>
  <p:sldSz cx="9144000" cy="12192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4994" autoAdjust="0"/>
    <p:restoredTop sz="94660"/>
  </p:normalViewPr>
  <p:slideViewPr>
    <p:cSldViewPr snapToGrid="0">
      <p:cViewPr>
        <p:scale>
          <a:sx n="123" d="100"/>
          <a:sy n="123" d="100"/>
        </p:scale>
        <p:origin x="590" y="5126"/>
      </p:cViewPr>
      <p:guideLst>
        <p:guide orient="horz" pos="384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995312"/>
            <a:ext cx="7772400" cy="4244622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6403623"/>
            <a:ext cx="6858000" cy="2943577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943657-9751-47B5-A1FC-C708563DD5F5}" type="datetimeFigureOut">
              <a:rPr kumimoji="1" lang="ja-JP" altLang="en-US" smtClean="0"/>
              <a:t>2016/6/6</a:t>
            </a:fld>
            <a:endParaRPr kumimoji="1"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C8703C-3351-4C2D-8E3C-CF4F1D608828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1425675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943657-9751-47B5-A1FC-C708563DD5F5}" type="datetimeFigureOut">
              <a:rPr kumimoji="1" lang="ja-JP" altLang="en-US" smtClean="0"/>
              <a:t>2016/6/6</a:t>
            </a:fld>
            <a:endParaRPr kumimoji="1"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C8703C-3351-4C2D-8E3C-CF4F1D608828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4690497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6" y="649111"/>
            <a:ext cx="1971675" cy="10332156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1" y="649111"/>
            <a:ext cx="5800725" cy="10332156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943657-9751-47B5-A1FC-C708563DD5F5}" type="datetimeFigureOut">
              <a:rPr kumimoji="1" lang="ja-JP" altLang="en-US" smtClean="0"/>
              <a:t>2016/6/6</a:t>
            </a:fld>
            <a:endParaRPr kumimoji="1"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C8703C-3351-4C2D-8E3C-CF4F1D608828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2123364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943657-9751-47B5-A1FC-C708563DD5F5}" type="datetimeFigureOut">
              <a:rPr kumimoji="1" lang="ja-JP" altLang="en-US" smtClean="0"/>
              <a:t>2016/6/6</a:t>
            </a:fld>
            <a:endParaRPr kumimoji="1"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C8703C-3351-4C2D-8E3C-CF4F1D608828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8637656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3039537"/>
            <a:ext cx="7886700" cy="5071532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8159048"/>
            <a:ext cx="7886700" cy="2666999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943657-9751-47B5-A1FC-C708563DD5F5}" type="datetimeFigureOut">
              <a:rPr kumimoji="1" lang="ja-JP" altLang="en-US" smtClean="0"/>
              <a:t>2016/6/6</a:t>
            </a:fld>
            <a:endParaRPr kumimoji="1"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C8703C-3351-4C2D-8E3C-CF4F1D608828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9010553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3245556"/>
            <a:ext cx="3886200" cy="7735712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3245556"/>
            <a:ext cx="3886200" cy="7735712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943657-9751-47B5-A1FC-C708563DD5F5}" type="datetimeFigureOut">
              <a:rPr kumimoji="1" lang="ja-JP" altLang="en-US" smtClean="0"/>
              <a:t>2016/6/6</a:t>
            </a:fld>
            <a:endParaRPr kumimoji="1" lang="ja-JP" alt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C8703C-3351-4C2D-8E3C-CF4F1D608828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481108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649114"/>
            <a:ext cx="7886700" cy="2356556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2988734"/>
            <a:ext cx="3868340" cy="146473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4453467"/>
            <a:ext cx="3868340" cy="6550379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1" y="2988734"/>
            <a:ext cx="3887391" cy="146473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1" y="4453467"/>
            <a:ext cx="3887391" cy="6550379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943657-9751-47B5-A1FC-C708563DD5F5}" type="datetimeFigureOut">
              <a:rPr kumimoji="1" lang="ja-JP" altLang="en-US" smtClean="0"/>
              <a:t>2016/6/6</a:t>
            </a:fld>
            <a:endParaRPr kumimoji="1" lang="ja-JP" alt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C8703C-3351-4C2D-8E3C-CF4F1D608828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5339627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943657-9751-47B5-A1FC-C708563DD5F5}" type="datetimeFigureOut">
              <a:rPr kumimoji="1" lang="ja-JP" altLang="en-US" smtClean="0"/>
              <a:t>2016/6/6</a:t>
            </a:fld>
            <a:endParaRPr kumimoji="1" lang="ja-JP" alt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C8703C-3351-4C2D-8E3C-CF4F1D608828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41504264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943657-9751-47B5-A1FC-C708563DD5F5}" type="datetimeFigureOut">
              <a:rPr kumimoji="1" lang="ja-JP" altLang="en-US" smtClean="0"/>
              <a:t>2016/6/6</a:t>
            </a:fld>
            <a:endParaRPr kumimoji="1" lang="ja-JP" alt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C8703C-3351-4C2D-8E3C-CF4F1D608828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1144428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812800"/>
            <a:ext cx="2949178" cy="28448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1755425"/>
            <a:ext cx="4629150" cy="8664222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3657600"/>
            <a:ext cx="2949178" cy="6776156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943657-9751-47B5-A1FC-C708563DD5F5}" type="datetimeFigureOut">
              <a:rPr kumimoji="1" lang="ja-JP" altLang="en-US" smtClean="0"/>
              <a:t>2016/6/6</a:t>
            </a:fld>
            <a:endParaRPr kumimoji="1" lang="ja-JP" alt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C8703C-3351-4C2D-8E3C-CF4F1D608828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8565079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812800"/>
            <a:ext cx="2949178" cy="28448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1755425"/>
            <a:ext cx="4629150" cy="8664222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 dirty="0" smtClean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3657600"/>
            <a:ext cx="2949178" cy="6776156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943657-9751-47B5-A1FC-C708563DD5F5}" type="datetimeFigureOut">
              <a:rPr kumimoji="1" lang="ja-JP" altLang="en-US" smtClean="0"/>
              <a:t>2016/6/6</a:t>
            </a:fld>
            <a:endParaRPr kumimoji="1" lang="ja-JP" alt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C8703C-3351-4C2D-8E3C-CF4F1D608828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42696059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649114"/>
            <a:ext cx="7886700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3245556"/>
            <a:ext cx="7886700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11300181"/>
            <a:ext cx="205740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D943657-9751-47B5-A1FC-C708563DD5F5}" type="datetimeFigureOut">
              <a:rPr kumimoji="1" lang="ja-JP" altLang="en-US" smtClean="0"/>
              <a:t>2016/6/6</a:t>
            </a:fld>
            <a:endParaRPr kumimoji="1"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11300181"/>
            <a:ext cx="308610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11300181"/>
            <a:ext cx="205740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C8703C-3351-4C2D-8E3C-CF4F1D608828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2631686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表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51446043"/>
              </p:ext>
            </p:extLst>
          </p:nvPr>
        </p:nvGraphicFramePr>
        <p:xfrm>
          <a:off x="1983784" y="732642"/>
          <a:ext cx="5005952" cy="8720580"/>
        </p:xfrm>
        <a:graphic>
          <a:graphicData uri="http://schemas.openxmlformats.org/drawingml/2006/table">
            <a:tbl>
              <a:tblPr/>
              <a:tblGrid>
                <a:gridCol w="757725"/>
                <a:gridCol w="593673"/>
                <a:gridCol w="469652"/>
                <a:gridCol w="124021"/>
                <a:gridCol w="317681"/>
                <a:gridCol w="573437"/>
                <a:gridCol w="395174"/>
                <a:gridCol w="124019"/>
                <a:gridCol w="867905"/>
                <a:gridCol w="782665"/>
              </a:tblGrid>
              <a:tr h="312267">
                <a:tc gridSpan="10"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Supplement Table 1. Immune mediator levels in aqueous humor of patients with </a:t>
                      </a:r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malignant uveal 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melanoma and </a:t>
                      </a:r>
                      <a:r>
                        <a:rPr lang="en-US" sz="1000" b="0" i="0" u="none" strike="noStrike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those with age-related 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macular </a:t>
                      </a:r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degeneration</a:t>
                      </a:r>
                      <a:r>
                        <a:rPr lang="en-US" sz="1000" b="0" i="0" u="none" strike="noStrike" dirty="0" smtClean="0">
                          <a:solidFill>
                            <a:srgbClr val="0070C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 </a:t>
                      </a:r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(ARMD)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  <a:tr h="312267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 </a:t>
                      </a: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gridSpan="3"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Malignant uveal melanoma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l" fontAlgn="ctr"/>
                      <a:endParaRPr lang="ja-JP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ARMD</a:t>
                      </a: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237593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　</a:t>
                      </a: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　</a:t>
                      </a: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 (n = 13)</a:t>
                      </a: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l" fontAlgn="ctr"/>
                      <a:endParaRPr lang="ja-JP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　</a:t>
                      </a: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 (n = 12)</a:t>
                      </a: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　</a:t>
                      </a: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 values</a:t>
                      </a: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8231">
                <a:tc>
                  <a:txBody>
                    <a:bodyPr/>
                    <a:lstStyle/>
                    <a:p>
                      <a:pPr algn="l" fontAlgn="ctr"/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gridSpan="3">
                  <a:txBody>
                    <a:bodyPr/>
                    <a:lstStyle/>
                    <a:p>
                      <a:pPr algn="l" fontAlgn="ctr"/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l" fontAlgn="ctr"/>
                      <a:endParaRPr lang="ja-JP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ctr"/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64499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Angiogenin (pg/ml)</a:t>
                      </a: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0941.7 (6823.1-18919.0)</a:t>
                      </a: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5103.4 (4007.2-6266.2)</a:t>
                      </a: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0007</a:t>
                      </a: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64499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bFGF (pg/ml)</a:t>
                      </a: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9.5 (0-0)</a:t>
                      </a: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l" fontAlgn="ctr"/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</a:t>
                      </a: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ctr"/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3545</a:t>
                      </a: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64499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CD40 ligand (pg/ml)</a:t>
                      </a: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</a:t>
                      </a: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</a:t>
                      </a: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ctr"/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64499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Eotaxin (pg/ml)</a:t>
                      </a: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</a:t>
                      </a: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</a:t>
                      </a: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ctr"/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64499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Fas ligand (pg/ml)</a:t>
                      </a: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70.9 (0-33.6)</a:t>
                      </a: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3.4 (9.2-16.8)</a:t>
                      </a: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2578</a:t>
                      </a: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64499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G-CSF (pg/ml)</a:t>
                      </a: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.2 (0-5.0)</a:t>
                      </a: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l" fontAlgn="ctr"/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</a:t>
                      </a: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ctr"/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5542</a:t>
                      </a: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64499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GM-CSF (pg/ml)</a:t>
                      </a: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</a:t>
                      </a: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</a:t>
                      </a: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ctr"/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64499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IFN-</a:t>
                      </a:r>
                      <a:r>
                        <a:rPr lang="el-G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γ (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g/ml)</a:t>
                      </a: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4 (0-0)</a:t>
                      </a: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l" fontAlgn="ctr"/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</a:t>
                      </a: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ctr"/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7442</a:t>
                      </a: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64499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IL-1</a:t>
                      </a:r>
                      <a:r>
                        <a:rPr lang="el-G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α (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g/ml)</a:t>
                      </a: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</a:t>
                      </a: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</a:t>
                      </a: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ctr"/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64499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IL-1</a:t>
                      </a:r>
                      <a:r>
                        <a:rPr lang="el-G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β (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g/ml)</a:t>
                      </a: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</a:t>
                      </a: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</a:t>
                      </a: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ctr"/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64499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IL-2 (pg/ml)</a:t>
                      </a: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</a:t>
                      </a: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</a:t>
                      </a: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ctr"/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64499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IL-3 (pg/ml)</a:t>
                      </a: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</a:t>
                      </a: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</a:t>
                      </a: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ctr"/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64499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IL-4 (pg/ml)</a:t>
                      </a: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</a:t>
                      </a: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</a:t>
                      </a: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ctr"/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64499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IL-5 (pg/ml)</a:t>
                      </a: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.7 (0-0)</a:t>
                      </a: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l" fontAlgn="ctr"/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</a:t>
                      </a: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ctr"/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5139</a:t>
                      </a: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64499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IL-6 (pg/ml)</a:t>
                      </a: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101.7 (11.3-429.1)</a:t>
                      </a: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7.4 (1.3-6.2)</a:t>
                      </a: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0007</a:t>
                      </a: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64499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IL-8 (pg/ml)</a:t>
                      </a: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489.8 (34.0-300.7)</a:t>
                      </a: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7.6 (3.1-6.6)</a:t>
                      </a: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0003</a:t>
                      </a: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81863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IL-9 (pg/ml)</a:t>
                      </a: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</a:t>
                      </a: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3"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ja-JP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</a:t>
                      </a: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ctr"/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81863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IL-10 (pg/ml)</a:t>
                      </a: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.9 (0-0)</a:t>
                      </a: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3"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ja-JP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</a:t>
                      </a: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ctr"/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3545</a:t>
                      </a: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81863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IL-11 (pg/ml)</a:t>
                      </a: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.6 (0-0)</a:t>
                      </a: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3"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ja-JP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</a:t>
                      </a: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ctr"/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5139</a:t>
                      </a: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81863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IL-12p70 (pg/ml)</a:t>
                      </a: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</a:t>
                      </a: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3"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ja-JP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</a:t>
                      </a: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ctr"/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81863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IL-17A (pg/ml)</a:t>
                      </a: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4 (0-0)</a:t>
                      </a: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3"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ja-JP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</a:t>
                      </a: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ctr"/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5139</a:t>
                      </a: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81863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IL-21 (pg/ml)</a:t>
                      </a: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.8 (0-0)</a:t>
                      </a: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3"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ja-JP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</a:t>
                      </a: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ctr"/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7442</a:t>
                      </a: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64499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IP-10 (pg/ml)</a:t>
                      </a: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060.8 (216.1-571.2)</a:t>
                      </a: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91.3 (34.8-81.0)</a:t>
                      </a: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0003</a:t>
                      </a: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81863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ITAC (pg/ml)</a:t>
                      </a: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</a:t>
                      </a: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3"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ja-JP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</a:t>
                      </a: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ctr"/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81863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LT-</a:t>
                      </a:r>
                      <a:r>
                        <a:rPr lang="el-G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α (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g/ml)</a:t>
                      </a: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</a:t>
                      </a: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3"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ja-JP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</a:t>
                      </a: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ctr"/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64499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MCP-1 (pg/ml)</a:t>
                      </a: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264.8 (721.3-2682.6)</a:t>
                      </a: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324.5 (245.9-322.9)</a:t>
                      </a: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0001</a:t>
                      </a: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64499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Mig (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g/ml)</a:t>
                      </a: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4"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743.0 (79.3-529.9)</a:t>
                      </a: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6.1 (5.2-14.5)</a:t>
                      </a: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0008</a:t>
                      </a: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64499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MIP-1</a:t>
                      </a:r>
                      <a:r>
                        <a:rPr lang="el-G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α (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g/ml)</a:t>
                      </a: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9 (0-0)</a:t>
                      </a: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l" fontAlgn="ctr"/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</a:t>
                      </a: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ctr"/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7442</a:t>
                      </a: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64499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MIP-1</a:t>
                      </a:r>
                      <a:r>
                        <a:rPr lang="el-G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β (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g/ml)</a:t>
                      </a: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1.6 (0-22.3)</a:t>
                      </a: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4.9 (0-9.0)</a:t>
                      </a: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0644</a:t>
                      </a: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64499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RANTES (pg/ml)</a:t>
                      </a: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123.6 (0-3.4)</a:t>
                      </a: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.5 (0-0)</a:t>
                      </a: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3014</a:t>
                      </a: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81863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TNF-</a:t>
                      </a:r>
                      <a:r>
                        <a:rPr lang="el-G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α (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pg/ml)</a:t>
                      </a: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</a:t>
                      </a: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3"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ja-JP" alt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</a:t>
                      </a: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ctr"/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</a:endParaRP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72725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VEGF (pg/ml)</a:t>
                      </a: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259.1 (16.0-297.0)</a:t>
                      </a: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71.1 (33.6-100.6)</a:t>
                      </a: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0.7188</a:t>
                      </a: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4499">
                <a:tc gridSpan="10"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Immune mediator levels are expressed as mean with </a:t>
                      </a:r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interquartile 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range in parenthesis.</a:t>
                      </a: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  <a:tr h="1072372">
                <a:tc gridSpan="10">
                  <a:txBody>
                    <a:bodyPr/>
                    <a:lstStyle/>
                    <a:p>
                      <a:pPr marL="0" marR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ARMD = age related macular degeneration; bFGF = basic fibroblast growth </a:t>
                      </a:r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factor;</a:t>
                      </a:r>
                      <a:r>
                        <a:rPr lang="en-US" sz="10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 </a:t>
                      </a:r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G-CSF = granulocyte-colony stimulating factor; GM-CSF = granulocyte macrophage-colony stimulating factor; IFN = interferon; IL = interleukin;  IP-10 = interferon gamma-induced  protein 10 coda; ITAC = interferon-inducible T-cell alpha chemoattractant; LT-</a:t>
                      </a:r>
                      <a:r>
                        <a:rPr lang="el-GR" altLang="ja-JP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α = </a:t>
                      </a:r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lymph toxin-</a:t>
                      </a:r>
                      <a:r>
                        <a:rPr lang="el-GR" altLang="ja-JP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α; </a:t>
                      </a:r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MCP = monocyte chemoattractant protein; Mig = monokine induced by interferon </a:t>
                      </a:r>
                      <a:r>
                        <a:rPr lang="el-GR" altLang="ja-JP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γ; </a:t>
                      </a:r>
                      <a:r>
                        <a:rPr lang="en-US" altLang="ja-JP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</a:rPr>
                        <a:t>MIP = macrophage inflammatory protein; RANTES = regulated upon activation, normal T expressed, and presumably secreted; TNF = tumor necrosis factor; VEGF = vascular endothelial growth factor</a:t>
                      </a:r>
                    </a:p>
                  </a:txBody>
                  <a:tcPr marL="8245" marR="8245" marT="824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73708610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75</TotalTime>
  <Words>467</Words>
  <Application>Microsoft Office PowerPoint</Application>
  <PresentationFormat>ユーザー設定</PresentationFormat>
  <Paragraphs>128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usuyoshi</dc:creator>
  <cp:lastModifiedBy>meditrans</cp:lastModifiedBy>
  <cp:revision>10</cp:revision>
  <dcterms:created xsi:type="dcterms:W3CDTF">2014-08-25T19:10:17Z</dcterms:created>
  <dcterms:modified xsi:type="dcterms:W3CDTF">2016-06-06T04:37:59Z</dcterms:modified>
</cp:coreProperties>
</file>